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0066A-CF2B-43A1-AEA7-CA6C03C13F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F482D-3250-448D-B78C-0CC8A3990E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CC6B67-3367-4B8F-BBEE-92C0B0839E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65C9D-2BB3-4FDF-A666-ED109EAC86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2505EE-898C-45DF-B140-BF770416B1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67F05A-9C1B-4C7E-A520-8080B8650F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E380D5-02B6-40CC-99D2-A0FC0BB3A3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85BB7-0A29-4851-9DA5-669597337D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85E98-AF14-4E6A-8B86-3593E38E84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3D3EF-7F30-42E6-BD25-D002C4F10A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A8971-6FC8-4298-92B8-5927635E8D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48B19C-4F68-406B-AF5D-1E125388DC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6C1022-0EA0-4F4A-B70D-50CA69E2F92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C:\Users\Carolyn\AppData\Local\Temp\A2780 bcl2.tif"/>
          <p:cNvPicPr/>
          <p:nvPr/>
        </p:nvPicPr>
        <p:blipFill>
          <a:blip r:embed="rId1">
            <a:grayscl/>
          </a:blip>
          <a:srcRect l="42735" t="21721" r="50155" b="75003"/>
          <a:stretch/>
        </p:blipFill>
        <p:spPr>
          <a:xfrm>
            <a:off x="1195560" y="1852560"/>
            <a:ext cx="771480" cy="442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4" descr="C:\Users\Carolyn\AppData\Local\Temp\A2780 bcl2.tif"/>
          <p:cNvPicPr/>
          <p:nvPr/>
        </p:nvPicPr>
        <p:blipFill>
          <a:blip r:embed="rId2">
            <a:grayscl/>
          </a:blip>
          <a:srcRect l="42735" t="15624" r="50155" b="81096"/>
          <a:stretch/>
        </p:blipFill>
        <p:spPr>
          <a:xfrm>
            <a:off x="1195560" y="2424240"/>
            <a:ext cx="771480" cy="442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Box 3"/>
          <p:cNvSpPr/>
          <p:nvPr/>
        </p:nvSpPr>
        <p:spPr>
          <a:xfrm rot="16200000">
            <a:off x="421560" y="732600"/>
            <a:ext cx="192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2780ADR 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"/>
          <p:cNvSpPr/>
          <p:nvPr/>
        </p:nvSpPr>
        <p:spPr>
          <a:xfrm rot="16200000">
            <a:off x="603360" y="560160"/>
            <a:ext cx="228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2780ADR Bcl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" name="Straight Arrow Connector 8"/>
          <p:cNvCxnSpPr/>
          <p:nvPr/>
        </p:nvCxnSpPr>
        <p:spPr>
          <a:xfrm>
            <a:off x="909360" y="2044800"/>
            <a:ext cx="214920" cy="21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lg"/>
          </a:ln>
        </p:spPr>
      </p:cxnSp>
      <p:cxnSp>
        <p:nvCxnSpPr>
          <p:cNvPr id="46" name="Straight Arrow Connector 10"/>
          <p:cNvCxnSpPr/>
          <p:nvPr/>
        </p:nvCxnSpPr>
        <p:spPr>
          <a:xfrm>
            <a:off x="909360" y="2708280"/>
            <a:ext cx="214920" cy="21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lg"/>
          </a:ln>
        </p:spPr>
      </p:cxnSp>
      <p:sp>
        <p:nvSpPr>
          <p:cNvPr id="47" name="TextBox 11"/>
          <p:cNvSpPr/>
          <p:nvPr/>
        </p:nvSpPr>
        <p:spPr>
          <a:xfrm>
            <a:off x="-57240" y="1900080"/>
            <a:ext cx="100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cl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-133200" y="2563920"/>
            <a:ext cx="108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2714760" y="380880"/>
            <a:ext cx="3638520" cy="2824560"/>
            <a:chOff x="2714760" y="380880"/>
            <a:chExt cx="3638520" cy="2824560"/>
          </a:xfrm>
        </p:grpSpPr>
        <p:pic>
          <p:nvPicPr>
            <p:cNvPr id="50" name="" descr=""/>
            <p:cNvPicPr/>
            <p:nvPr/>
          </p:nvPicPr>
          <p:blipFill>
            <a:blip r:embed="rId3"/>
            <a:stretch/>
          </p:blipFill>
          <p:spPr>
            <a:xfrm>
              <a:off x="2714760" y="380880"/>
              <a:ext cx="3638520" cy="2600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2778480" y="2746440"/>
              <a:ext cx="9842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 </a:t>
              </a:r>
              <a:r>
                <a:rPr b="0" lang="el-GR" sz="12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 Do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0 </a:t>
              </a:r>
              <a:r>
                <a:rPr b="0" lang="el-GR" sz="1200" spc="-1" strike="noStrike">
                  <a:solidFill>
                    <a:srgbClr val="000000"/>
                  </a:solidFill>
                  <a:latin typeface="Arial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 Lov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730680" y="2746440"/>
              <a:ext cx="270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426200" y="2746440"/>
              <a:ext cx="269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119920" y="2746440"/>
              <a:ext cx="270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816880" y="2746440"/>
              <a:ext cx="2696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"/>
          <p:cNvSpPr/>
          <p:nvPr/>
        </p:nvSpPr>
        <p:spPr>
          <a:xfrm>
            <a:off x="36360" y="25236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505240" y="250920"/>
            <a:ext cx="49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12840" y="3440160"/>
            <a:ext cx="628488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Supplementary Figure 2.  Bcl-2 overexpression does not inhibit cell death triggered by the lovastatin and doxorubicin in A2780ADR cells.  </a:t>
            </a:r>
            <a:r>
              <a:rPr b="0" lang="en-CA" sz="1200" spc="-1" strike="noStrike">
                <a:solidFill>
                  <a:srgbClr val="000000"/>
                </a:solidFill>
                <a:latin typeface="Arial"/>
              </a:rPr>
              <a:t>Bcl-2 or a GFP empty vector control was ectopically introduced into A2780ADR cells.  A: Expression of Bcl-2 was confirmed by immunoblotting with tubulin used as a loading control.  B: Cells were exposed to either a control, 10 μM lovastatin, 7 μM doxorubicin, or both 10 μM lovastatin and 7 μM doxorubicin together.  Fixed PI experiments were performed to determine the proportion of dead cells (PreG1 population) for each treatment condition.  Data are presented as the mean of 3-4 independent experiments with error bars representing standard deviation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21T14:58:55Z</dcterms:created>
  <dc:creator>Jamie</dc:creator>
  <dc:description/>
  <dc:language>en-US</dc:language>
  <cp:lastModifiedBy>Jamie</cp:lastModifiedBy>
  <dcterms:modified xsi:type="dcterms:W3CDTF">2010-02-21T23:11:34Z</dcterms:modified>
  <cp:revision>4</cp:revision>
  <dc:subject/>
  <dc:title>Slide 1</dc:title>
</cp:coreProperties>
</file>